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0" d="100"/>
          <a:sy n="60" d="100"/>
        </p:scale>
        <p:origin x="-2094" y="32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27E47-0199-444D-A482-4645ACB9A8D4}" type="datetimeFigureOut">
              <a:rPr lang="en-SG" smtClean="0"/>
              <a:pPr/>
              <a:t>6/2/2015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88C8-4862-4C55-BE2C-D415D15A9619}" type="slidenum">
              <a:rPr lang="en-SG" smtClean="0"/>
              <a:pPr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27E47-0199-444D-A482-4645ACB9A8D4}" type="datetimeFigureOut">
              <a:rPr lang="en-SG" smtClean="0"/>
              <a:pPr/>
              <a:t>6/2/2015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88C8-4862-4C55-BE2C-D415D15A9619}" type="slidenum">
              <a:rPr lang="en-SG" smtClean="0"/>
              <a:pPr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27E47-0199-444D-A482-4645ACB9A8D4}" type="datetimeFigureOut">
              <a:rPr lang="en-SG" smtClean="0"/>
              <a:pPr/>
              <a:t>6/2/2015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88C8-4862-4C55-BE2C-D415D15A9619}" type="slidenum">
              <a:rPr lang="en-SG" smtClean="0"/>
              <a:pPr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27E47-0199-444D-A482-4645ACB9A8D4}" type="datetimeFigureOut">
              <a:rPr lang="en-SG" smtClean="0"/>
              <a:pPr/>
              <a:t>6/2/2015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88C8-4862-4C55-BE2C-D415D15A9619}" type="slidenum">
              <a:rPr lang="en-SG" smtClean="0"/>
              <a:pPr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27E47-0199-444D-A482-4645ACB9A8D4}" type="datetimeFigureOut">
              <a:rPr lang="en-SG" smtClean="0"/>
              <a:pPr/>
              <a:t>6/2/2015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88C8-4862-4C55-BE2C-D415D15A9619}" type="slidenum">
              <a:rPr lang="en-SG" smtClean="0"/>
              <a:pPr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27E47-0199-444D-A482-4645ACB9A8D4}" type="datetimeFigureOut">
              <a:rPr lang="en-SG" smtClean="0"/>
              <a:pPr/>
              <a:t>6/2/2015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88C8-4862-4C55-BE2C-D415D15A9619}" type="slidenum">
              <a:rPr lang="en-SG" smtClean="0"/>
              <a:pPr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27E47-0199-444D-A482-4645ACB9A8D4}" type="datetimeFigureOut">
              <a:rPr lang="en-SG" smtClean="0"/>
              <a:pPr/>
              <a:t>6/2/2015</a:t>
            </a:fld>
            <a:endParaRPr lang="en-SG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88C8-4862-4C55-BE2C-D415D15A9619}" type="slidenum">
              <a:rPr lang="en-SG" smtClean="0"/>
              <a:pPr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27E47-0199-444D-A482-4645ACB9A8D4}" type="datetimeFigureOut">
              <a:rPr lang="en-SG" smtClean="0"/>
              <a:pPr/>
              <a:t>6/2/2015</a:t>
            </a:fld>
            <a:endParaRPr lang="en-SG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88C8-4862-4C55-BE2C-D415D15A9619}" type="slidenum">
              <a:rPr lang="en-SG" smtClean="0"/>
              <a:pPr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27E47-0199-444D-A482-4645ACB9A8D4}" type="datetimeFigureOut">
              <a:rPr lang="en-SG" smtClean="0"/>
              <a:pPr/>
              <a:t>6/2/2015</a:t>
            </a:fld>
            <a:endParaRPr lang="en-SG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88C8-4862-4C55-BE2C-D415D15A9619}" type="slidenum">
              <a:rPr lang="en-SG" smtClean="0"/>
              <a:pPr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27E47-0199-444D-A482-4645ACB9A8D4}" type="datetimeFigureOut">
              <a:rPr lang="en-SG" smtClean="0"/>
              <a:pPr/>
              <a:t>6/2/2015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88C8-4862-4C55-BE2C-D415D15A9619}" type="slidenum">
              <a:rPr lang="en-SG" smtClean="0"/>
              <a:pPr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SG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27E47-0199-444D-A482-4645ACB9A8D4}" type="datetimeFigureOut">
              <a:rPr lang="en-SG" smtClean="0"/>
              <a:pPr/>
              <a:t>6/2/2015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88C8-4862-4C55-BE2C-D415D15A9619}" type="slidenum">
              <a:rPr lang="en-SG" smtClean="0"/>
              <a:pPr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E27E47-0199-444D-A482-4645ACB9A8D4}" type="datetimeFigureOut">
              <a:rPr lang="en-SG" smtClean="0"/>
              <a:pPr/>
              <a:t>6/2/2015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F888C8-4862-4C55-BE2C-D415D15A9619}" type="slidenum">
              <a:rPr lang="en-SG" smtClean="0"/>
              <a:pPr/>
              <a:t>‹#›</a:t>
            </a:fld>
            <a:endParaRPr lang="en-SG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/>
        </p:nvGraphicFramePr>
        <p:xfrm>
          <a:off x="260648" y="668432"/>
          <a:ext cx="6336703" cy="9109104"/>
        </p:xfrm>
        <a:graphic>
          <a:graphicData uri="http://schemas.openxmlformats.org/drawingml/2006/table">
            <a:tbl>
              <a:tblPr/>
              <a:tblGrid>
                <a:gridCol w="1468260"/>
                <a:gridCol w="2060132"/>
                <a:gridCol w="1904249"/>
                <a:gridCol w="904062"/>
              </a:tblGrid>
              <a:tr h="216024"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ene Name</a:t>
                      </a:r>
                    </a:p>
                  </a:txBody>
                  <a:tcPr marL="3083" marR="3083" marT="308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CBI GENE</a:t>
                      </a:r>
                      <a:r>
                        <a:rPr lang="en-US" sz="1200" b="0" i="0" u="none" strike="noStrike" baseline="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Accession Number 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ercentage of Viral Antigen Positive Cells (%)</a:t>
                      </a:r>
                    </a:p>
                  </a:txBody>
                  <a:tcPr marL="3083" marR="3083" marT="308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tandard Error</a:t>
                      </a:r>
                    </a:p>
                  </a:txBody>
                  <a:tcPr marL="3083" marR="3083" marT="308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AK1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02576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7.439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4.789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INK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15716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2.975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669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AP4K2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04579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3.539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.419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EK3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152720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4.282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.558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EK11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145910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9.253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.689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TK3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06281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0.065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4.698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AP2K5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02757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2.985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1.534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EK7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133494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3.990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.407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AK2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02577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5.166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000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AP2K4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03010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5.928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.248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AP4K3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03618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6.247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8.667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AP3K8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05204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6.387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000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EK9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33116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8.445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7.158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AP3K14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03954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9.685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.366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EK1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12224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9.790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000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TK10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05990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0.751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.275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AK3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02578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6.037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.275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LS2CR2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18571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8.207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.381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AK4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01014834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8.828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2.934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AK7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20341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9.201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1.295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AK6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20168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82.522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.380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AP3K2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06609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83.369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.255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AP3K3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02401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83.501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.108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EK6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14397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86.319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5.849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AP4K5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06575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87.139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6.437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KIAA1361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20791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87.940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4.540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AP4K4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04834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89.862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.387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AP2K3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02756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0.539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.693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EK2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02497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2.233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.729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YO3A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17433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4.093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.087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P6-213H19.1</a:t>
                      </a:r>
                    </a:p>
                  </a:txBody>
                  <a:tcPr marL="3083" marR="3083" marT="308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01042452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5.656</a:t>
                      </a:r>
                    </a:p>
                  </a:txBody>
                  <a:tcPr marL="3083" marR="3083" marT="308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0.682</a:t>
                      </a:r>
                    </a:p>
                  </a:txBody>
                  <a:tcPr marL="3083" marR="3083" marT="308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AP3K5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05923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6.144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.229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OSR1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05109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6.628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0.209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TK25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06374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7.609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.622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TK24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03576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8.286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0.639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NIK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15028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8.799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.579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DC7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03503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02.236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.117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EK4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03157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04.872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.218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LJ23074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01018046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07.219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.110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AP2K7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145185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07.970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000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YK5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01003786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09.653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.048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AP3K4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06724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09.706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.127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JIK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16281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10.159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0.788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AP2K1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02755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11.259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.378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AP2K6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02758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11.988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.549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AP2K2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30662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14.729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.059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4493">
                <a:tc>
                  <a:txBody>
                    <a:bodyPr/>
                    <a:lstStyle/>
                    <a:p>
                      <a:pPr algn="ctr" fontAlgn="ctr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LK</a:t>
                      </a: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M_014720</a:t>
                      </a:r>
                      <a:endParaRPr lang="en-SG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3083" marR="3083" marT="308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15.852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SG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.142</a:t>
                      </a:r>
                    </a:p>
                  </a:txBody>
                  <a:tcPr marL="3083" marR="3083" marT="308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404664" y="272480"/>
            <a:ext cx="590465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SG" sz="1200" b="1" dirty="0" smtClean="0">
                <a:latin typeface="Times New Roman" pitchFamily="18" charset="0"/>
                <a:ea typeface="Tahoma" pitchFamily="34" charset="0"/>
                <a:cs typeface="Times New Roman" pitchFamily="18" charset="0"/>
              </a:rPr>
              <a:t>Table S1. </a:t>
            </a:r>
            <a:r>
              <a:rPr lang="en-SG" sz="1200" dirty="0" smtClean="0">
                <a:latin typeface="Times New Roman" pitchFamily="18" charset="0"/>
                <a:ea typeface="Tahoma" pitchFamily="34" charset="0"/>
                <a:cs typeface="Times New Roman" pitchFamily="18" charset="0"/>
              </a:rPr>
              <a:t>List Of Human Serine/</a:t>
            </a:r>
            <a:r>
              <a:rPr lang="en-SG" sz="1200" dirty="0" err="1" smtClean="0">
                <a:latin typeface="Times New Roman" pitchFamily="18" charset="0"/>
                <a:ea typeface="Tahoma" pitchFamily="34" charset="0"/>
                <a:cs typeface="Times New Roman" pitchFamily="18" charset="0"/>
              </a:rPr>
              <a:t>Threonine</a:t>
            </a:r>
            <a:r>
              <a:rPr lang="en-SG" sz="1200" dirty="0" smtClean="0">
                <a:latin typeface="Times New Roman" pitchFamily="18" charset="0"/>
                <a:ea typeface="Tahoma" pitchFamily="34" charset="0"/>
                <a:cs typeface="Times New Roman" pitchFamily="18" charset="0"/>
              </a:rPr>
              <a:t> </a:t>
            </a:r>
            <a:r>
              <a:rPr lang="en-SG" sz="1200" dirty="0" err="1" smtClean="0">
                <a:latin typeface="Times New Roman" pitchFamily="18" charset="0"/>
                <a:ea typeface="Tahoma" pitchFamily="34" charset="0"/>
                <a:cs typeface="Times New Roman" pitchFamily="18" charset="0"/>
              </a:rPr>
              <a:t>Kinases</a:t>
            </a:r>
            <a:r>
              <a:rPr lang="en-SG" sz="1200" dirty="0" smtClean="0">
                <a:latin typeface="Times New Roman" pitchFamily="18" charset="0"/>
                <a:ea typeface="Tahoma" pitchFamily="34" charset="0"/>
                <a:cs typeface="Times New Roman" pitchFamily="18" charset="0"/>
              </a:rPr>
              <a:t> Targeted</a:t>
            </a:r>
          </a:p>
          <a:p>
            <a:endParaRPr lang="en-SG" sz="1200" b="1" dirty="0">
              <a:latin typeface="Times New Roman" pitchFamily="18" charset="0"/>
              <a:ea typeface="Tahoma" pitchFamily="34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</TotalTime>
  <Words>212</Words>
  <Application>Microsoft Office PowerPoint</Application>
  <PresentationFormat>A4 Paper (210x297 mm)</PresentationFormat>
  <Paragraphs>19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Grizli777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erene</dc:creator>
  <cp:lastModifiedBy>Serene</cp:lastModifiedBy>
  <cp:revision>68</cp:revision>
  <dcterms:created xsi:type="dcterms:W3CDTF">2013-11-23T12:48:45Z</dcterms:created>
  <dcterms:modified xsi:type="dcterms:W3CDTF">2015-02-06T13:26:05Z</dcterms:modified>
</cp:coreProperties>
</file>